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Bubble_plot_order_allf_cssna15.png"/>
          <p:cNvPicPr>
            <a:picLocks noChangeAspect="1"/>
          </p:cNvPicPr>
          <p:nvPr/>
        </p:nvPicPr>
        <p:blipFill>
          <a:blip r:embed="rId2" cstate="print"/>
          <a:srcRect l="80392" t="13095" b="17857"/>
          <a:stretch>
            <a:fillRect/>
          </a:stretch>
        </p:blipFill>
        <p:spPr>
          <a:xfrm>
            <a:off x="7239000" y="1600200"/>
            <a:ext cx="1016000" cy="3314700"/>
          </a:xfrm>
          <a:prstGeom prst="rect">
            <a:avLst/>
          </a:prstGeom>
        </p:spPr>
      </p:pic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4572000" y="285749"/>
          <a:ext cx="2539998" cy="4950587"/>
        </p:xfrm>
        <a:graphic>
          <a:graphicData uri="http://schemas.openxmlformats.org/drawingml/2006/table">
            <a:tbl>
              <a:tblPr/>
              <a:tblGrid>
                <a:gridCol w="423333"/>
                <a:gridCol w="423333"/>
                <a:gridCol w="423333"/>
                <a:gridCol w="423333"/>
                <a:gridCol w="423333"/>
                <a:gridCol w="423333"/>
              </a:tblGrid>
              <a:tr h="21628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5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A </a:t>
                      </a:r>
                      <a:r>
                        <a:rPr lang="en-IN" sz="5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5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B</a:t>
                      </a:r>
                      <a:endParaRPr lang="en-IN" sz="5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5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A </a:t>
                      </a:r>
                      <a:r>
                        <a:rPr lang="en-IN" sz="5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5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G</a:t>
                      </a:r>
                      <a:endParaRPr lang="en-IN" sz="5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5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A </a:t>
                      </a:r>
                      <a:r>
                        <a:rPr lang="en-IN" sz="5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5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N</a:t>
                      </a:r>
                      <a:endParaRPr lang="en-IN" sz="5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5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B </a:t>
                      </a:r>
                      <a:r>
                        <a:rPr lang="en-IN" sz="5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5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G</a:t>
                      </a:r>
                      <a:endParaRPr lang="en-IN" sz="5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5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B </a:t>
                      </a:r>
                      <a:r>
                        <a:rPr lang="en-IN" sz="5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5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N</a:t>
                      </a:r>
                      <a:endParaRPr lang="en-IN" sz="5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5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G </a:t>
                      </a:r>
                      <a:r>
                        <a:rPr lang="en-IN" sz="500" b="1" dirty="0" err="1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vs</a:t>
                      </a:r>
                      <a:r>
                        <a:rPr lang="en-IN" sz="500" b="1" dirty="0" smtClean="0">
                          <a:latin typeface="Arial Rounded MT Bold" pitchFamily="34" charset="0"/>
                          <a:ea typeface="Calibri"/>
                          <a:cs typeface="Times New Roman"/>
                        </a:rPr>
                        <a:t> N</a:t>
                      </a:r>
                      <a:endParaRPr lang="en-IN" sz="500" b="1" dirty="0">
                        <a:latin typeface="Arial Rounded MT Bold" pitchFamily="34" charset="0"/>
                        <a:ea typeface="Calibri"/>
                        <a:cs typeface="Times New Roman"/>
                      </a:endParaRPr>
                    </a:p>
                  </a:txBody>
                  <a:tcPr marL="37069" marR="37069" marT="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IN" sz="500" b="1" dirty="0" smtClean="0">
                          <a:latin typeface="Arial Rounded MT Bold" pitchFamily="34" charset="0"/>
                        </a:rPr>
                        <a:t>**</a:t>
                      </a:r>
                      <a:endParaRPr lang="en-IN" sz="500" b="1" dirty="0">
                        <a:latin typeface="Arial Rounded MT Bold" pitchFamily="34" charset="0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IN" sz="500" b="1" dirty="0" smtClean="0">
                          <a:latin typeface="Arial Rounded MT Bold" pitchFamily="34" charset="0"/>
                        </a:rPr>
                        <a:t>*</a:t>
                      </a:r>
                      <a:endParaRPr lang="en-IN" sz="500" b="1" dirty="0">
                        <a:latin typeface="Arial Rounded MT Bold" pitchFamily="34" charset="0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IN" sz="500" b="1" dirty="0" smtClean="0">
                          <a:latin typeface="Arial Rounded MT Bold" pitchFamily="34" charset="0"/>
                        </a:rPr>
                        <a:t>**</a:t>
                      </a:r>
                      <a:endParaRPr lang="en-IN" sz="500" b="1" dirty="0">
                        <a:latin typeface="Arial Rounded MT Bold" pitchFamily="34" charset="0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en-IN" sz="500" b="1" dirty="0">
                        <a:latin typeface="Arial Rounded MT Bold" pitchFamily="34" charset="0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en-IN" sz="500" b="1" dirty="0">
                        <a:latin typeface="Arial Rounded MT Bold" pitchFamily="34" charset="0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500" b="1" dirty="0" smtClean="0">
                          <a:latin typeface="Arial Rounded MT Bold" pitchFamily="34" charset="0"/>
                          <a:ea typeface="Calibri"/>
                        </a:rPr>
                        <a:t>*</a:t>
                      </a: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1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4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001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500" b="0" dirty="0">
                        <a:latin typeface="Arial Rounded MT Bold" pitchFamily="34" charset="0"/>
                        <a:ea typeface="Calibri"/>
                      </a:endParaRPr>
                    </a:p>
                  </a:txBody>
                  <a:tcPr marL="44173" marR="4417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pic>
        <p:nvPicPr>
          <p:cNvPr id="5" name="Picture 4" descr="Bubble_plot_order_allf_cssna15.png"/>
          <p:cNvPicPr>
            <a:picLocks noChangeAspect="1"/>
          </p:cNvPicPr>
          <p:nvPr/>
        </p:nvPicPr>
        <p:blipFill>
          <a:blip r:embed="rId3" cstate="print"/>
          <a:srcRect r="20000"/>
          <a:stretch>
            <a:fillRect/>
          </a:stretch>
        </p:blipFill>
        <p:spPr>
          <a:xfrm>
            <a:off x="508001" y="457200"/>
            <a:ext cx="4064009" cy="51435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14400" y="5657671"/>
            <a:ext cx="7620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S5</a:t>
            </a:r>
            <a:r>
              <a:rPr lang="en-US" dirty="0" smtClean="0"/>
              <a:t>:</a:t>
            </a:r>
            <a:r>
              <a:rPr lang="en-US" b="1" dirty="0" smtClean="0"/>
              <a:t> </a:t>
            </a:r>
            <a:r>
              <a:rPr lang="en-US" dirty="0" smtClean="0"/>
              <a:t>Differential abundance of gut </a:t>
            </a:r>
            <a:r>
              <a:rPr lang="en-US" dirty="0" err="1" smtClean="0"/>
              <a:t>microbiota</a:t>
            </a:r>
            <a:r>
              <a:rPr lang="en-US" dirty="0" smtClean="0"/>
              <a:t> in </a:t>
            </a:r>
            <a:r>
              <a:rPr lang="en-US" dirty="0" smtClean="0"/>
              <a:t> different </a:t>
            </a:r>
            <a:r>
              <a:rPr lang="en-US" dirty="0" smtClean="0"/>
              <a:t>breeds or line at order level. All orders with or without </a:t>
            </a:r>
            <a:r>
              <a:rPr lang="en-US" dirty="0" smtClean="0"/>
              <a:t> significant </a:t>
            </a:r>
            <a:r>
              <a:rPr lang="en-US" dirty="0" smtClean="0"/>
              <a:t>(P&lt;0.05) difference in relative abundance among </a:t>
            </a:r>
            <a:r>
              <a:rPr lang="en-US" dirty="0" smtClean="0"/>
              <a:t>groups identified </a:t>
            </a:r>
            <a:r>
              <a:rPr lang="en-US" dirty="0" smtClean="0"/>
              <a:t>with </a:t>
            </a:r>
            <a:r>
              <a:rPr lang="en-US" dirty="0" err="1" smtClean="0"/>
              <a:t>edgeR</a:t>
            </a:r>
            <a:r>
              <a:rPr lang="en-US" dirty="0" smtClean="0"/>
              <a:t> were plotted.</a:t>
            </a:r>
            <a:endParaRPr lang="en-IN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22</Words>
  <Application>Microsoft Office PowerPoint</Application>
  <PresentationFormat>On-screen Show (4:3)</PresentationFormat>
  <Paragraphs>7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yam</dc:creator>
  <cp:lastModifiedBy>Shyam</cp:lastModifiedBy>
  <cp:revision>6</cp:revision>
  <dcterms:created xsi:type="dcterms:W3CDTF">2006-08-16T00:00:00Z</dcterms:created>
  <dcterms:modified xsi:type="dcterms:W3CDTF">2020-12-20T12:58:30Z</dcterms:modified>
</cp:coreProperties>
</file>